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  <p:sldMasterId id="2147483660" r:id="rId2"/>
  </p:sldMasterIdLst>
  <p:notesMasterIdLst>
    <p:notesMasterId r:id="rId10"/>
  </p:notesMasterIdLst>
  <p:sldIdLst>
    <p:sldId id="280" r:id="rId3"/>
    <p:sldId id="283" r:id="rId4"/>
    <p:sldId id="289" r:id="rId5"/>
    <p:sldId id="301" r:id="rId6"/>
    <p:sldId id="292" r:id="rId7"/>
    <p:sldId id="302" r:id="rId8"/>
    <p:sldId id="303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49"/>
    <p:restoredTop sz="94694"/>
  </p:normalViewPr>
  <p:slideViewPr>
    <p:cSldViewPr snapToGrid="0">
      <p:cViewPr>
        <p:scale>
          <a:sx n="69" d="100"/>
          <a:sy n="69" d="100"/>
        </p:scale>
        <p:origin x="380" y="1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presProps" Target="presProps.xml"/><Relationship Id="rId5" Type="http://schemas.openxmlformats.org/officeDocument/2006/relationships/slide" Target="slides/slide3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F63211-AA61-4F6A-9BF7-BA0487A8FF67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630D2D-FB63-4D9B-A81F-EB6FD5D624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40236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9630D2D-FB63-4D9B-A81F-EB6FD5D6247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47108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DA08A2F-BD95-41BE-8B15-F4117597AAD2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5831603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67362-C0C8-074F-834F-AF1E1C938B13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B082B-06B8-E440-A134-21679015788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67362-C0C8-074F-834F-AF1E1C938B13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B082B-06B8-E440-A134-21679015788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67362-C0C8-074F-834F-AF1E1C938B13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B082B-06B8-E440-A134-21679015788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B835E0-B6DD-4EF8-AC5D-2BF692B4A57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95A0799-0142-448B-92FF-F7B5EB0E4E1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3E9BA1-3CB6-4F96-BC17-8332BD7A82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63D87-028B-4392-8682-B04A2340FB56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7A0EC9-B311-4A66-B0D6-81749AE8F7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79DB46-0D41-4C57-A2DB-EDC110602C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2F9F9-CECE-4700-8B84-7F9189565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14277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96995B-7BF3-4342-8BE8-382F967D2F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0E3F9D-7C76-4665-BBD0-19EDF542C3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28E57B-4CF3-451E-AAA5-121AE770F1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63D87-028B-4392-8682-B04A2340FB56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2F9E98-84CA-44EE-AF03-3025C0071D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273BE4-12C6-47CE-901C-CC4E48FA6B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2F9F9-CECE-4700-8B84-7F9189565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2808096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7D20BD-49FF-42B6-A4B3-49AD5E8169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B979CD-F499-4D72-B0FD-B7DE9ED22C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9608A4-C34F-4435-AF19-16BA7EF7DB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63D87-028B-4392-8682-B04A2340FB56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1CFC49-52F3-4147-BA9F-0770EA6428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1C750F-D913-4113-B66A-CF0F9393B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2F9F9-CECE-4700-8B84-7F9189565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7510570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448CE7-5E2B-47D6-B88B-23334EC3C7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A22A09-13FA-4EA1-9E21-F267E1CC134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3FCBB35-A7BF-4DDF-9B7D-26CACA266C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FF95E2-EE2B-4E50-A974-A8C346C104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63D87-028B-4392-8682-B04A2340FB56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704F7A-FF66-4767-B47F-CDB4AEC391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C5769F-8640-4350-87D5-18622252AB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2F9F9-CECE-4700-8B84-7F9189565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868175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6B568A-F00C-44BB-B8F0-4614B8A70D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CF9625-A7CC-413B-9EA7-C36824677D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22EA67-AE6B-4630-81DD-EACC802C08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FC87CD6-DC00-4D77-97C5-A2BB43650E5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24E1BB9-594F-4D48-BDE5-0D25A70101E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32EB47C-808D-425C-A72D-B9E093F454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63D87-028B-4392-8682-B04A2340FB56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6707342-2635-43CD-8833-CA437DF2E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E4CF48B-8857-4B63-84C3-6FADF3C9AE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2F9F9-CECE-4700-8B84-7F9189565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196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28F939-1842-4882-8B2C-2E8C1DEDB3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CD3F634-008F-4FFD-A7F0-304C5ECEC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63D87-028B-4392-8682-B04A2340FB56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E5287DA-D922-48FC-9BC4-D3B5080D64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DFDF88-EE6F-403E-B9BD-1BC3DCE244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2F9F9-CECE-4700-8B84-7F9189565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51357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77FC68F-59B4-476B-842D-737A2A113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63D87-028B-4392-8682-B04A2340FB56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43BD035-3681-4AA8-88E1-23891C20FB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9B3271F-C763-4E4A-BD01-4484C521C4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2F9F9-CECE-4700-8B84-7F9189565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774146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FFC11C-C208-4842-8C7E-5FFA5716FA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258114-989D-46D1-B5BD-105F2491F2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547C651-FFB9-427C-AFA7-8C9F198BD0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BDDAB6-1969-4DB4-9C06-7A5D2060F0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63D87-028B-4392-8682-B04A2340FB56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308128-68C4-4001-96A5-908C893313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BC9B971-9398-4920-87C7-B259C30A56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2F9F9-CECE-4700-8B84-7F9189565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914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67362-C0C8-074F-834F-AF1E1C938B13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B082B-06B8-E440-A134-21679015788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0914F-2274-45DF-B6A8-DEB446F0F7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125A853-8FD7-486B-B0ED-CD9D8D0CCE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C81337B-D268-475F-92E2-6333E6C87E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997808-F54A-4734-A61F-ECC123FAC1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63D87-028B-4392-8682-B04A2340FB56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F6DB3D-3F6A-45FB-AF3C-BE96EBC170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908D06-D01E-4BE2-839C-026B41F72F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2F9F9-CECE-4700-8B84-7F9189565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79084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283B39-279D-488E-836F-7F0775E66C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B0BD6A-48E4-4EB7-8225-5E7FF549AE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4C0F3D-659A-4FFC-986E-4000EDCDD4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63D87-028B-4392-8682-B04A2340FB56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08B289-12D2-414D-AE00-2062E0543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CF9855-4145-4C38-A234-BAD34F9CC4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2F9F9-CECE-4700-8B84-7F9189565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879207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217DA99-E65D-425F-BB51-FD5AD3916DF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9620EA7-CD09-44CF-8D36-9E8A4617AC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804607-EFE6-4669-BE61-40C40C7012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63D87-028B-4392-8682-B04A2340FB56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BB93CC-F00F-41AB-84E7-6D1B5580F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4D563C-19EA-4BA2-B3C5-1B2DB13B28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2F9F9-CECE-4700-8B84-7F9189565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63142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67362-C0C8-074F-834F-AF1E1C938B13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B082B-06B8-E440-A134-21679015788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67362-C0C8-074F-834F-AF1E1C938B13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B082B-06B8-E440-A134-21679015788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67362-C0C8-074F-834F-AF1E1C938B13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B082B-06B8-E440-A134-21679015788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67362-C0C8-074F-834F-AF1E1C938B13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B082B-06B8-E440-A134-21679015788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67362-C0C8-074F-834F-AF1E1C938B13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B082B-06B8-E440-A134-21679015788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67362-C0C8-074F-834F-AF1E1C938B13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B082B-06B8-E440-A134-21679015788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67362-C0C8-074F-834F-AF1E1C938B13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B082B-06B8-E440-A134-21679015788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D67362-C0C8-074F-834F-AF1E1C938B13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B082B-06B8-E440-A134-216790157881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38A4A2A-4B27-451E-9A6D-5A499E9345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AD6D41-AEDB-480E-872D-E7F1912035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C7B924-296D-4D47-A920-337A3820A6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763D87-028B-4392-8682-B04A2340FB56}" type="datetimeFigureOut">
              <a:rPr lang="en-US" smtClean="0"/>
              <a:t>11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B6139D-103F-4734-B594-3312484C7F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B5ED1E-419F-47BE-859E-8492A40E5A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72F9F9-CECE-4700-8B84-7F9189565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36913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11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7" Type="http://schemas.openxmlformats.org/officeDocument/2006/relationships/image" Target="../media/image15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3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14.png"/><Relationship Id="rId4" Type="http://schemas.openxmlformats.org/officeDocument/2006/relationships/image" Target="../media/image13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19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1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13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-79936"/>
            <a:ext cx="25773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6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 Black" panose="020B0A04020102020204" pitchFamily="34" charset="0"/>
                <a:ea typeface="+mn-ea"/>
                <a:cs typeface="Arial Black" panose="020B0A04020102020204" pitchFamily="34" charset="0"/>
              </a:rPr>
              <a:t>Figure S1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304800" y="66859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A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29725" y="1037926"/>
            <a:ext cx="1141414" cy="29933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26350" y="1037926"/>
            <a:ext cx="999824" cy="2993300"/>
          </a:xfrm>
          <a:prstGeom prst="rect">
            <a:avLst/>
          </a:prstGeom>
        </p:spPr>
      </p:pic>
      <p:cxnSp>
        <p:nvCxnSpPr>
          <p:cNvPr id="8" name="Straight Connector 7"/>
          <p:cNvCxnSpPr/>
          <p:nvPr/>
        </p:nvCxnSpPr>
        <p:spPr>
          <a:xfrm flipV="1">
            <a:off x="1563329" y="1927123"/>
            <a:ext cx="835742" cy="983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 flipV="1">
            <a:off x="1548584" y="2207339"/>
            <a:ext cx="835742" cy="983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 flipV="1">
            <a:off x="1583000" y="2821859"/>
            <a:ext cx="835742" cy="983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2448238" y="1307690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Rf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359744" y="1710813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0.85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354824" y="1991034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0.64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359741" y="2615383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0.34</a:t>
            </a:r>
          </a:p>
        </p:txBody>
      </p:sp>
      <p:cxnSp>
        <p:nvCxnSpPr>
          <p:cNvPr id="15" name="Straight Connector 14"/>
          <p:cNvCxnSpPr/>
          <p:nvPr/>
        </p:nvCxnSpPr>
        <p:spPr>
          <a:xfrm flipV="1">
            <a:off x="3937832" y="2728452"/>
            <a:ext cx="835742" cy="983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V="1">
            <a:off x="3932912" y="3126656"/>
            <a:ext cx="835742" cy="983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4714572" y="2541641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0.34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719485" y="2910348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0.17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822733" y="1342106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Rf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984094" y="72267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7DA1F24-58D7-6425-CAA0-852DF306F0A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63277" y="1037925"/>
            <a:ext cx="1501829" cy="2993301"/>
          </a:xfrm>
          <a:prstGeom prst="rect">
            <a:avLst/>
          </a:prstGeom>
        </p:spPr>
      </p:pic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0D794D9C-D365-5ECE-0651-1749951F672E}"/>
              </a:ext>
            </a:extLst>
          </p:cNvPr>
          <p:cNvCxnSpPr>
            <a:cxnSpLocks/>
          </p:cNvCxnSpPr>
          <p:nvPr/>
        </p:nvCxnSpPr>
        <p:spPr>
          <a:xfrm flipV="1">
            <a:off x="6953518" y="2710576"/>
            <a:ext cx="1100595" cy="2309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EFEABD03-9CA2-C76B-00F4-63E7479C5FB7}"/>
              </a:ext>
            </a:extLst>
          </p:cNvPr>
          <p:cNvCxnSpPr>
            <a:cxnSpLocks/>
          </p:cNvCxnSpPr>
          <p:nvPr/>
        </p:nvCxnSpPr>
        <p:spPr>
          <a:xfrm flipV="1">
            <a:off x="7179809" y="3149303"/>
            <a:ext cx="1100595" cy="2309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348A8C8C-9122-57B6-524D-4F1C3AEBDAB5}"/>
              </a:ext>
            </a:extLst>
          </p:cNvPr>
          <p:cNvSpPr txBox="1"/>
          <p:nvPr/>
        </p:nvSpPr>
        <p:spPr>
          <a:xfrm>
            <a:off x="8217094" y="1328255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Rf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B75B468-EA9B-4089-343C-5EE5A94A0530}"/>
              </a:ext>
            </a:extLst>
          </p:cNvPr>
          <p:cNvSpPr txBox="1"/>
          <p:nvPr/>
        </p:nvSpPr>
        <p:spPr>
          <a:xfrm>
            <a:off x="8063350" y="2535089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.4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81B3DD0-7306-FA7F-E3D7-BAE912D6FED8}"/>
              </a:ext>
            </a:extLst>
          </p:cNvPr>
          <p:cNvSpPr txBox="1"/>
          <p:nvPr/>
        </p:nvSpPr>
        <p:spPr>
          <a:xfrm>
            <a:off x="8238841" y="2969203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.2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92A7360-6421-7786-BC14-028BFFD0EE1B}"/>
              </a:ext>
            </a:extLst>
          </p:cNvPr>
          <p:cNvSpPr txBox="1"/>
          <p:nvPr/>
        </p:nvSpPr>
        <p:spPr>
          <a:xfrm>
            <a:off x="5694964" y="718061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3B25B1C-2FC2-8AD9-9B62-BB5B8BD405E3}"/>
              </a:ext>
            </a:extLst>
          </p:cNvPr>
          <p:cNvSpPr txBox="1"/>
          <p:nvPr/>
        </p:nvSpPr>
        <p:spPr>
          <a:xfrm>
            <a:off x="461819" y="4489163"/>
            <a:ext cx="1094509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Figure S1: </a:t>
            </a:r>
            <a:r>
              <a:rPr lang="en-US" sz="1800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TLC analysis of the chloroform (A) and </a:t>
            </a:r>
            <a:r>
              <a:rPr lang="en-US" sz="18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queous alcoholic extract </a:t>
            </a:r>
            <a:r>
              <a:rPr lang="en-US" sz="1800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(B and C) of Ag-Iba</a:t>
            </a:r>
            <a:r>
              <a:rPr lang="en-US" dirty="0"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sz="1800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 TLC in CH</a:t>
            </a:r>
            <a:r>
              <a:rPr lang="en-US" sz="1800" baseline="-25000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sz="1800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Cl</a:t>
            </a:r>
            <a:r>
              <a:rPr lang="en-US" sz="1800" baseline="-25000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sz="1800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/MeOH 12:1</a:t>
            </a:r>
            <a:r>
              <a:rPr lang="en-US" dirty="0"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revealed that the </a:t>
            </a:r>
            <a:r>
              <a:rPr lang="en-US" sz="18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queous alcoholic extract </a:t>
            </a:r>
            <a:r>
              <a:rPr lang="en-US" sz="1800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contained a component with the same Rf as kaempferol (0.45)(Figure S1C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562568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0086" y="1073963"/>
            <a:ext cx="10515600" cy="324379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855FFB5-3E2B-45B6-AACD-75EBB0FB4CD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1971" y="4485538"/>
            <a:ext cx="5113925" cy="218802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6000" y="4201794"/>
            <a:ext cx="5514975" cy="2471774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303633" y="1650672"/>
            <a:ext cx="8973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ample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400559" y="2820084"/>
            <a:ext cx="14327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tandard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9496" y="165867"/>
            <a:ext cx="43261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solidFill>
                  <a:srgbClr val="FF0000"/>
                </a:solidFill>
                <a:latin typeface="Arial Black" panose="020B0A04020102020204" pitchFamily="34" charset="0"/>
                <a:cs typeface="Arial Black" panose="020B0A04020102020204" pitchFamily="34" charset="0"/>
              </a:rPr>
              <a:t>Figure S2A</a:t>
            </a:r>
          </a:p>
        </p:txBody>
      </p:sp>
      <p:sp>
        <p:nvSpPr>
          <p:cNvPr id="7" name="Rectangle 6"/>
          <p:cNvSpPr/>
          <p:nvPr/>
        </p:nvSpPr>
        <p:spPr>
          <a:xfrm>
            <a:off x="4319824" y="314319"/>
            <a:ext cx="7754189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/>
              <a:t>Confirmation of Kaempferol:  LC (tops) and MS/MS (bottom) revealed that the sample and standard have the same retention time and fragmentation pattern. 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09E8D344-E5F2-ECF4-7F3B-0BF5DDD9C1E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1663399"/>
              </p:ext>
            </p:extLst>
          </p:nvPr>
        </p:nvGraphicFramePr>
        <p:xfrm>
          <a:off x="7814556" y="2843634"/>
          <a:ext cx="1450339" cy="7902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64-bit Drawing" r:id="rId5" imgW="1698806" imgH="926154" progId="ChemDraw_x64.Document.6.0">
                  <p:embed/>
                </p:oleObj>
              </mc:Choice>
              <mc:Fallback>
                <p:oleObj name="CS ChemDraw 64-bit Drawing" r:id="rId5" imgW="1698806" imgH="926154" progId="ChemDraw_x64.Document.6.0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CAEAFC6F-C460-FA30-6D04-2164DF7A364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814556" y="2843634"/>
                        <a:ext cx="1450339" cy="7902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1679684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45253" y="1040868"/>
            <a:ext cx="10515600" cy="322791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CD2FA29-05E3-4E9A-AAB6-4D7989C125B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0520" y="4398652"/>
            <a:ext cx="5098732" cy="2313214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03053" y="4268780"/>
            <a:ext cx="5543550" cy="2443086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286421" y="1741189"/>
            <a:ext cx="8973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ample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383347" y="2910601"/>
            <a:ext cx="14327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tandard</a:t>
            </a: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3213219" y="3026782"/>
            <a:ext cx="205099" cy="45292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2664445" y="2838736"/>
            <a:ext cx="19569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utin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en-US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Source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Fragment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9496" y="165867"/>
            <a:ext cx="43261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solidFill>
                  <a:srgbClr val="FF0000"/>
                </a:solidFill>
                <a:latin typeface="Arial Black" panose="020B0A04020102020204" pitchFamily="34" charset="0"/>
                <a:cs typeface="Arial Black" panose="020B0A04020102020204" pitchFamily="34" charset="0"/>
              </a:rPr>
              <a:t>Figure S2B</a:t>
            </a:r>
          </a:p>
        </p:txBody>
      </p:sp>
      <p:sp>
        <p:nvSpPr>
          <p:cNvPr id="16" name="Rectangle 15"/>
          <p:cNvSpPr/>
          <p:nvPr/>
        </p:nvSpPr>
        <p:spPr>
          <a:xfrm>
            <a:off x="4319824" y="314319"/>
            <a:ext cx="7754189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/>
              <a:t>Confirmation of Quercetin:  LC (tops) and MS/MS (bottom) revealed that the sample and standard have the same retention time and fragmentation pattern. 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B8B51F63-C4D1-720A-2949-3C9AAF1879C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22337318"/>
              </p:ext>
            </p:extLst>
          </p:nvPr>
        </p:nvGraphicFramePr>
        <p:xfrm>
          <a:off x="8162597" y="1347497"/>
          <a:ext cx="1307592" cy="8468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64-bit Drawing" r:id="rId5" imgW="1698806" imgH="1100036" progId="ChemDraw_x64.Document.6.0">
                  <p:embed/>
                </p:oleObj>
              </mc:Choice>
              <mc:Fallback>
                <p:oleObj name="CS ChemDraw 64-bit Drawing" r:id="rId5" imgW="1698806" imgH="1100036" progId="ChemDraw_x64.Document.6.0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1F53EBF5-C750-19D6-6EF8-354032DB57B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162597" y="1347497"/>
                        <a:ext cx="1307592" cy="8468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3125242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5466" y="784473"/>
            <a:ext cx="11816534" cy="388576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E1FAEAA-F57A-440E-9046-9045AB18608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5875" y="4530197"/>
            <a:ext cx="4850190" cy="218802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54047" y="4530197"/>
            <a:ext cx="4969218" cy="2188029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034041" y="1805343"/>
            <a:ext cx="8973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ample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130967" y="2974755"/>
            <a:ext cx="14327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tandard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9496" y="47883"/>
            <a:ext cx="43261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solidFill>
                  <a:srgbClr val="FF0000"/>
                </a:solidFill>
                <a:latin typeface="Arial Black" panose="020B0A04020102020204" pitchFamily="34" charset="0"/>
                <a:cs typeface="Arial Black" panose="020B0A04020102020204" pitchFamily="34" charset="0"/>
              </a:rPr>
              <a:t>Figure S2C</a:t>
            </a:r>
          </a:p>
        </p:txBody>
      </p:sp>
      <p:sp>
        <p:nvSpPr>
          <p:cNvPr id="15" name="Rectangle 14"/>
          <p:cNvSpPr/>
          <p:nvPr/>
        </p:nvSpPr>
        <p:spPr>
          <a:xfrm>
            <a:off x="4319824" y="176671"/>
            <a:ext cx="7754189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/>
              <a:t>Confirmation of </a:t>
            </a:r>
            <a:r>
              <a:rPr lang="en-US" sz="1600" dirty="0">
                <a:solidFill>
                  <a:prstClr val="black"/>
                </a:solidFill>
              </a:rPr>
              <a:t>Myricetin</a:t>
            </a:r>
            <a:r>
              <a:rPr lang="en-US" sz="1600" dirty="0"/>
              <a:t>:  LC (tops) and MS/MS (bottom) revealed that the sample and standard have the same retention time and fragmentation pattern. 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911E4B58-3402-5D5B-815A-161F5A8C33B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2819523"/>
              </p:ext>
            </p:extLst>
          </p:nvPr>
        </p:nvGraphicFramePr>
        <p:xfrm>
          <a:off x="8851398" y="1475339"/>
          <a:ext cx="1556066" cy="10068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64-bit Drawing" r:id="rId6" imgW="1700421" imgH="1100036" progId="ChemDraw_x64.Document.6.0">
                  <p:embed/>
                </p:oleObj>
              </mc:Choice>
              <mc:Fallback>
                <p:oleObj name="CS ChemDraw 64-bit Drawing" r:id="rId6" imgW="1700421" imgH="1100036" progId="ChemDraw_x64.Document.6.0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375562F1-C565-3EB2-2AEF-53E7BDE00DB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8851398" y="1475339"/>
                        <a:ext cx="1556066" cy="10068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466901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801" y="990772"/>
            <a:ext cx="11282495" cy="3395407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FCA8845-5EFC-4A75-ACB0-CDB5242F64C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1094" y="4173981"/>
            <a:ext cx="4503216" cy="262345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14998" y="4262190"/>
            <a:ext cx="5003251" cy="2466881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807163" y="1796399"/>
            <a:ext cx="8973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ample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904089" y="2965811"/>
            <a:ext cx="14327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tandard</a:t>
            </a:r>
          </a:p>
        </p:txBody>
      </p:sp>
      <p:sp>
        <p:nvSpPr>
          <p:cNvPr id="3" name="Rectangle 2"/>
          <p:cNvSpPr/>
          <p:nvPr/>
        </p:nvSpPr>
        <p:spPr>
          <a:xfrm>
            <a:off x="4911442" y="3244334"/>
            <a:ext cx="6415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err="1"/>
              <a:t>Rutin</a:t>
            </a:r>
            <a:endParaRPr lang="en-US" sz="1600" dirty="0"/>
          </a:p>
        </p:txBody>
      </p:sp>
      <p:sp>
        <p:nvSpPr>
          <p:cNvPr id="12" name="TextBox 11"/>
          <p:cNvSpPr txBox="1"/>
          <p:nvPr/>
        </p:nvSpPr>
        <p:spPr>
          <a:xfrm>
            <a:off x="29496" y="47883"/>
            <a:ext cx="43261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solidFill>
                  <a:srgbClr val="FF0000"/>
                </a:solidFill>
                <a:latin typeface="Arial Black" panose="020B0A04020102020204" pitchFamily="34" charset="0"/>
                <a:cs typeface="Arial Black" panose="020B0A04020102020204" pitchFamily="34" charset="0"/>
              </a:rPr>
              <a:t>Figure S2D</a:t>
            </a:r>
          </a:p>
        </p:txBody>
      </p:sp>
      <p:sp>
        <p:nvSpPr>
          <p:cNvPr id="13" name="Rectangle 12"/>
          <p:cNvSpPr/>
          <p:nvPr/>
        </p:nvSpPr>
        <p:spPr>
          <a:xfrm>
            <a:off x="4319824" y="176671"/>
            <a:ext cx="7754189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/>
              <a:t>Confirmation of Rutin:  LC (tops) and MS/MS (bottom) revealed that the sample and standard have the same retention time and fragmentation pattern. 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29929A3D-8BCF-9816-7B22-BAFA3E6ACE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09231771"/>
              </p:ext>
            </p:extLst>
          </p:nvPr>
        </p:nvGraphicFramePr>
        <p:xfrm>
          <a:off x="7911395" y="2625921"/>
          <a:ext cx="1307592" cy="13592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64-bit Drawing" r:id="rId5" imgW="1810229" imgH="1881897" progId="ChemDraw_x64.Document.6.0">
                  <p:embed/>
                </p:oleObj>
              </mc:Choice>
              <mc:Fallback>
                <p:oleObj name="CS ChemDraw 64-bit Drawing" r:id="rId5" imgW="1810229" imgH="1881897" progId="ChemDraw_x64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4286F935-6FFA-B705-B38D-5C38E1FE7F7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911395" y="2625921"/>
                        <a:ext cx="1307592" cy="13592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7014149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9496" y="18384"/>
            <a:ext cx="50734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solidFill>
                  <a:srgbClr val="FF0000"/>
                </a:solidFill>
                <a:latin typeface="Arial Black" panose="020B0A04020102020204" pitchFamily="34" charset="0"/>
                <a:cs typeface="Arial Black" panose="020B0A04020102020204" pitchFamily="34" charset="0"/>
              </a:rPr>
              <a:t>Figure S3A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1466" y="1121185"/>
            <a:ext cx="4181475" cy="443865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02365" y="1121185"/>
            <a:ext cx="4293911" cy="443865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DA19131-81D4-A72E-BFC2-CEEB8A64688B}"/>
              </a:ext>
            </a:extLst>
          </p:cNvPr>
          <p:cNvSpPr txBox="1"/>
          <p:nvPr/>
        </p:nvSpPr>
        <p:spPr>
          <a:xfrm>
            <a:off x="434107" y="5657475"/>
            <a:ext cx="10160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Figure S3A: </a:t>
            </a:r>
            <a:r>
              <a:rPr lang="en-US" sz="18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Disc diffusion assay. </a:t>
            </a:r>
            <a:r>
              <a:rPr lang="en-US" sz="1800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Lack of zone of inhibition in the disc diffusion assay revealed that </a:t>
            </a:r>
            <a:r>
              <a:rPr lang="en-US" sz="18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g-Iba aqueous alcoholic extract </a:t>
            </a:r>
            <a:r>
              <a:rPr lang="en-US" dirty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i</a:t>
            </a:r>
            <a:r>
              <a:rPr lang="en-US" sz="18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s </a:t>
            </a:r>
            <a:r>
              <a:rPr lang="en-US" dirty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sz="18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evoid of anti-bacterial activity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0076178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9496" y="18384"/>
            <a:ext cx="50734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>
                <a:solidFill>
                  <a:srgbClr val="FF0000"/>
                </a:solidFill>
                <a:latin typeface="Arial Black" panose="020B0A04020102020204" pitchFamily="34" charset="0"/>
                <a:cs typeface="Arial Black" panose="020B0A04020102020204" pitchFamily="34" charset="0"/>
              </a:rPr>
              <a:t>Figure </a:t>
            </a:r>
            <a:r>
              <a:rPr lang="en-US" sz="3600" b="1" dirty="0">
                <a:solidFill>
                  <a:srgbClr val="FF0000"/>
                </a:solidFill>
                <a:latin typeface="Arial Black" panose="020B0A04020102020204" pitchFamily="34" charset="0"/>
                <a:cs typeface="Arial Black" panose="020B0A04020102020204" pitchFamily="34" charset="0"/>
              </a:rPr>
              <a:t>S3B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5078" y="968167"/>
            <a:ext cx="9172575" cy="104775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6818" y="2809724"/>
            <a:ext cx="2885309" cy="2235534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23617" y="2809724"/>
            <a:ext cx="2897070" cy="2235534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83425" y="2809724"/>
            <a:ext cx="2950297" cy="2235534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002508" y="2809724"/>
            <a:ext cx="2856516" cy="223553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8E3F2F5-80B1-6E04-F4D9-A8E1E1215577}"/>
              </a:ext>
            </a:extLst>
          </p:cNvPr>
          <p:cNvSpPr txBox="1"/>
          <p:nvPr/>
        </p:nvSpPr>
        <p:spPr>
          <a:xfrm>
            <a:off x="434106" y="5657475"/>
            <a:ext cx="1068647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Figure S3B: </a:t>
            </a:r>
            <a:r>
              <a:rPr lang="en-US" sz="18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MTS assay revealed that </a:t>
            </a:r>
            <a:r>
              <a:rPr lang="en-US" sz="1800" dirty="0"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g-Iba aqueous alcoholic extract has no significant deleterious effect on the viability of A549, MCF-7, Hep-G2, and Vero cells up to 1 mg/mL</a:t>
            </a:r>
            <a:r>
              <a:rPr lang="en-US" sz="18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165773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69</TotalTime>
  <Words>276</Words>
  <Application>Microsoft Office PowerPoint</Application>
  <PresentationFormat>Widescreen</PresentationFormat>
  <Paragraphs>39</Paragraphs>
  <Slides>7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2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5" baseType="lpstr">
      <vt:lpstr>SimSun</vt:lpstr>
      <vt:lpstr>Arial</vt:lpstr>
      <vt:lpstr>Arial Black</vt:lpstr>
      <vt:lpstr>Calibri</vt:lpstr>
      <vt:lpstr>Calibri Light</vt:lpstr>
      <vt:lpstr>Office Theme</vt:lpstr>
      <vt:lpstr>1_Office Theme</vt:lpstr>
      <vt:lpstr>CS ChemDraw 64-bit Drawing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lomon Owumi</dc:creator>
  <cp:lastModifiedBy>Oyelere, Adegboyega K</cp:lastModifiedBy>
  <cp:revision>69</cp:revision>
  <dcterms:created xsi:type="dcterms:W3CDTF">2023-07-16T14:20:00Z</dcterms:created>
  <dcterms:modified xsi:type="dcterms:W3CDTF">2024-11-22T01:55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89E7C8903B714D57B586EF9ED747380A</vt:lpwstr>
  </property>
  <property fmtid="{D5CDD505-2E9C-101B-9397-08002B2CF9AE}" pid="3" name="KSOProductBuildVer">
    <vt:lpwstr>1033-11.2.0.11225</vt:lpwstr>
  </property>
</Properties>
</file>